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589F54-9638-4ED0-9DD2-6E5F596227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A794E1D-F9B7-465F-BBE7-98417E48D0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BE33FD-C848-4C79-BD21-A2F3FF7D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5FF99B-46D1-4A66-84EF-B8068A998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6819DE-6630-46FF-88EE-D773C0AED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90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5D0F75-ADB4-43C7-B57F-5847AB25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669CCF-8A4E-4C9B-8D3B-E205AA4740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EDB19E-9A4C-4158-AFDC-BD2858DB8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A750C8-A3CB-4DC2-9244-084581A4E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BABCC8-3CA1-40A1-8B16-4C672C387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010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B6A6DD8-FD85-4842-9552-0164310F73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6A92639-ADAF-45CB-8602-311B853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BC7265-B805-4229-8D2C-159EA689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7B877B-39EF-4CE0-8834-A1496605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B1E688-FA19-4C8A-BCAF-0248B5C43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38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841825-2114-4F60-8806-EA5D8E76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5BE79-F3D6-4B94-8A00-598E329150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0E93D0-B517-49A7-A693-EAB7C7BA0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9648E0-8045-42DD-997F-0C78F0B20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8B9498-649D-43A8-A84B-BE1452EC4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07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7329B3-A826-4E04-A7BA-3FF90ED81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031C77-4291-4FEC-9CF9-D21FEE1480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75C001-5FDF-49B8-9B82-1A7A7ECE1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250721-7068-40E9-BEA4-376494394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229175-49B6-40D5-BD7C-03928E62B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3322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522050-1FEC-4189-9D49-DE410DFD6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F5C046-02F2-4CBA-861D-6C4FA5072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E3AAF0-DB63-40A9-B811-E08198152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64ABBB-8DFF-456A-A7AF-77077C989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EC15EA-85A1-4EF4-922C-03F8C9D3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C287C5-9D34-432E-9203-C5A04DC37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85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C4E259-3077-4458-9BD2-8A1C73A51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6A7148-9E4B-468A-A774-7854CCED3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A0237FD-2ACD-4A27-BCE1-3E4144E76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72A45EE-7E69-4353-84AE-165A4BB8F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77070B6-E232-48AF-AA19-4170C21A55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3EDCDC6-528B-494A-A0C6-288B0A1E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80D965E-3640-48A2-B5E5-A65B829C7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681FCFB-CFD6-42EE-B9D9-B942E6D54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32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DF23B7-EB3A-466B-97A3-87FB70E50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57D86E-7DC2-45D5-A6CF-8D61B5AF7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6700BA8-6646-4481-A017-CDEF360C2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1494AE5-2AF3-4760-A985-4FABD9E4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50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4108FD-946D-4195-A5C6-4FF3C8821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AD8363D-5DFE-4206-B1C4-D2E76E812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ED42A12-50FF-4CBF-B8AB-E4B9D68F9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75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14D13C-69BE-4E8F-B38C-9AC61DEE9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869D4F-F1CC-447E-9B86-719C561D0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6A1C6C9-1AA5-47CB-AF34-99CDB4049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A4896B-4DF5-4B9C-B849-2F38ED84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AA1D62D-53A8-4F40-9348-30308C411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6DB290-1A9E-4B4A-8D9D-56690FB12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07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F8AEEA-1E54-4AB7-82DB-B15E0377C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A961CD2-9612-43E9-8285-E331F6D2B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9FEB559-5DAD-41A5-ACF0-2C6636C2B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C14CD7-822B-42E7-9CE2-A492A85FF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AEB1C7-4CB1-407C-B664-1E7EE2EB8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8428F2-EA7C-40DB-BE75-6BFA3B619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073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3B4FF39-665D-457A-BCCD-BF45B99BE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12B9CD-DCE3-47F0-8DF4-7B1C5A397A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2246C7-AEF6-4D7E-8D86-B09914F77C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04AA1EB-85B6-4FDE-98C0-BA8E0357F1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5F4040-B936-4900-93CE-F38AEE77AE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052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e 28">
            <a:extLst>
              <a:ext uri="{FF2B5EF4-FFF2-40B4-BE49-F238E27FC236}">
                <a16:creationId xmlns:a16="http://schemas.microsoft.com/office/drawing/2014/main" id="{D2287BBE-C6D0-43EE-974E-B9AB1683C6B4}"/>
              </a:ext>
            </a:extLst>
          </p:cNvPr>
          <p:cNvGrpSpPr/>
          <p:nvPr/>
        </p:nvGrpSpPr>
        <p:grpSpPr>
          <a:xfrm>
            <a:off x="1596814" y="3003511"/>
            <a:ext cx="9030635" cy="1196799"/>
            <a:chOff x="-937526" y="379414"/>
            <a:chExt cx="9030635" cy="1196799"/>
          </a:xfrm>
        </p:grpSpPr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660BFAB4-DE15-4443-B4E9-A052A30FE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tx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676" y="971019"/>
              <a:ext cx="704873" cy="605194"/>
            </a:xfrm>
            <a:prstGeom prst="rect">
              <a:avLst/>
            </a:prstGeom>
          </p:spPr>
        </p:pic>
        <p:cxnSp>
          <p:nvCxnSpPr>
            <p:cNvPr id="9" name="Connecteur droit avec flèche 8">
              <a:extLst>
                <a:ext uri="{FF2B5EF4-FFF2-40B4-BE49-F238E27FC236}">
                  <a16:creationId xmlns:a16="http://schemas.microsoft.com/office/drawing/2014/main" id="{DED2D9F9-F7F8-406A-AF0D-324775B43540}"/>
                </a:ext>
              </a:extLst>
            </p:cNvPr>
            <p:cNvCxnSpPr/>
            <p:nvPr/>
          </p:nvCxnSpPr>
          <p:spPr>
            <a:xfrm>
              <a:off x="1740090" y="1273616"/>
              <a:ext cx="3698543" cy="0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ED8B4F81-16E4-4DA7-A7B9-F0BFCC8809D4}"/>
                </a:ext>
              </a:extLst>
            </p:cNvPr>
            <p:cNvSpPr txBox="1"/>
            <p:nvPr/>
          </p:nvSpPr>
          <p:spPr>
            <a:xfrm>
              <a:off x="5329452" y="1122317"/>
              <a:ext cx="2763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Sacrifice : Lung and spleen collection 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EFD65E34-A0D2-42A2-8F4E-005E7FA1236D}"/>
                </a:ext>
              </a:extLst>
            </p:cNvPr>
            <p:cNvSpPr txBox="1"/>
            <p:nvPr/>
          </p:nvSpPr>
          <p:spPr>
            <a:xfrm>
              <a:off x="-937526" y="1049511"/>
              <a:ext cx="12732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>
                  <a:solidFill>
                    <a:srgbClr val="0070C0"/>
                  </a:solidFill>
                </a:rPr>
                <a:t>ALPN-101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90EF21BB-978F-4B5E-BE49-8DEE911A0A0F}"/>
                </a:ext>
              </a:extLst>
            </p:cNvPr>
            <p:cNvSpPr txBox="1"/>
            <p:nvPr/>
          </p:nvSpPr>
          <p:spPr>
            <a:xfrm>
              <a:off x="1951631" y="1293412"/>
              <a:ext cx="3166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/>
                <a:t>i.p</a:t>
              </a:r>
              <a:r>
                <a:rPr lang="fr-FR" sz="1200" dirty="0"/>
                <a:t>. ALPN-101 injection : 2 </a:t>
              </a:r>
              <a:r>
                <a:rPr lang="fr-FR" sz="1200" dirty="0" err="1"/>
                <a:t>days</a:t>
              </a:r>
              <a:r>
                <a:rPr lang="fr-FR" sz="1200" dirty="0"/>
                <a:t>/</a:t>
              </a:r>
              <a:r>
                <a:rPr lang="fr-FR" sz="1200" dirty="0" err="1"/>
                <a:t>week</a:t>
              </a:r>
              <a:endParaRPr lang="fr-FR" sz="1200" dirty="0"/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B0FFFF78-72DA-44A3-8624-1D22B31AE5AD}"/>
                </a:ext>
              </a:extLst>
            </p:cNvPr>
            <p:cNvSpPr txBox="1"/>
            <p:nvPr/>
          </p:nvSpPr>
          <p:spPr>
            <a:xfrm>
              <a:off x="1252183" y="795270"/>
              <a:ext cx="9758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Day 1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E321AD61-943F-49AB-A5A0-A2A9B7058934}"/>
                </a:ext>
              </a:extLst>
            </p:cNvPr>
            <p:cNvSpPr txBox="1"/>
            <p:nvPr/>
          </p:nvSpPr>
          <p:spPr>
            <a:xfrm>
              <a:off x="4841544" y="794955"/>
              <a:ext cx="9758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Day 42</a:t>
              </a:r>
            </a:p>
          </p:txBody>
        </p:sp>
        <p:cxnSp>
          <p:nvCxnSpPr>
            <p:cNvPr id="25" name="Connecteur droit 24">
              <a:extLst>
                <a:ext uri="{FF2B5EF4-FFF2-40B4-BE49-F238E27FC236}">
                  <a16:creationId xmlns:a16="http://schemas.microsoft.com/office/drawing/2014/main" id="{C291AA6F-2D78-4A26-91CD-160EDDB87ACE}"/>
                </a:ext>
              </a:extLst>
            </p:cNvPr>
            <p:cNvCxnSpPr/>
            <p:nvPr/>
          </p:nvCxnSpPr>
          <p:spPr>
            <a:xfrm>
              <a:off x="1740090" y="1049511"/>
              <a:ext cx="0" cy="224105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>
              <a:extLst>
                <a:ext uri="{FF2B5EF4-FFF2-40B4-BE49-F238E27FC236}">
                  <a16:creationId xmlns:a16="http://schemas.microsoft.com/office/drawing/2014/main" id="{BCB82EA9-099C-4FC0-A393-999FC8A2BC63}"/>
                </a:ext>
              </a:extLst>
            </p:cNvPr>
            <p:cNvCxnSpPr/>
            <p:nvPr/>
          </p:nvCxnSpPr>
          <p:spPr>
            <a:xfrm>
              <a:off x="5329451" y="1042686"/>
              <a:ext cx="0" cy="224105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73F40C1D-7580-4CF2-A83C-83FA9DD7C419}"/>
                </a:ext>
              </a:extLst>
            </p:cNvPr>
            <p:cNvSpPr txBox="1"/>
            <p:nvPr/>
          </p:nvSpPr>
          <p:spPr>
            <a:xfrm>
              <a:off x="251476" y="379414"/>
              <a:ext cx="180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Fra-2 </a:t>
              </a:r>
              <a:r>
                <a:rPr lang="fr-FR" sz="1200" b="1" dirty="0" err="1"/>
                <a:t>mice</a:t>
              </a:r>
              <a:endParaRPr lang="fr-FR" sz="1200" b="1" dirty="0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7786B30B-B0D0-490A-8743-C3F6A442FA26}"/>
                </a:ext>
              </a:extLst>
            </p:cNvPr>
            <p:cNvSpPr txBox="1"/>
            <p:nvPr/>
          </p:nvSpPr>
          <p:spPr>
            <a:xfrm>
              <a:off x="251476" y="580329"/>
              <a:ext cx="180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i="1" dirty="0"/>
                <a:t>12 </a:t>
              </a:r>
              <a:r>
                <a:rPr lang="fr-FR" sz="1200" b="1" i="1" dirty="0" err="1"/>
                <a:t>weeks</a:t>
              </a:r>
              <a:r>
                <a:rPr lang="fr-FR" sz="1200" b="1" i="1" dirty="0"/>
                <a:t> </a:t>
              </a:r>
              <a:r>
                <a:rPr lang="fr-FR" sz="1200" b="1" i="1" dirty="0" err="1"/>
                <a:t>old</a:t>
              </a:r>
              <a:endParaRPr lang="fr-FR" sz="1200" b="1" i="1" dirty="0"/>
            </a:p>
          </p:txBody>
        </p:sp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AF7CE1F7-1171-460F-98D1-31A2C39EF2AE}"/>
              </a:ext>
            </a:extLst>
          </p:cNvPr>
          <p:cNvGrpSpPr/>
          <p:nvPr/>
        </p:nvGrpSpPr>
        <p:grpSpPr>
          <a:xfrm>
            <a:off x="1161408" y="1413614"/>
            <a:ext cx="9546593" cy="1197327"/>
            <a:chOff x="-1361363" y="379414"/>
            <a:chExt cx="9546593" cy="1197327"/>
          </a:xfrm>
        </p:grpSpPr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F94B469D-EEEE-497E-884E-664BC1105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tx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676" y="971019"/>
              <a:ext cx="704873" cy="605194"/>
            </a:xfrm>
            <a:prstGeom prst="rect">
              <a:avLst/>
            </a:prstGeom>
          </p:spPr>
        </p:pic>
        <p:cxnSp>
          <p:nvCxnSpPr>
            <p:cNvPr id="32" name="Connecteur droit avec flèche 31">
              <a:extLst>
                <a:ext uri="{FF2B5EF4-FFF2-40B4-BE49-F238E27FC236}">
                  <a16:creationId xmlns:a16="http://schemas.microsoft.com/office/drawing/2014/main" id="{FED2A142-1924-4D58-B450-324D01960216}"/>
                </a:ext>
              </a:extLst>
            </p:cNvPr>
            <p:cNvCxnSpPr/>
            <p:nvPr/>
          </p:nvCxnSpPr>
          <p:spPr>
            <a:xfrm>
              <a:off x="1740090" y="1273616"/>
              <a:ext cx="3698543" cy="0"/>
            </a:xfrm>
            <a:prstGeom prst="straightConnector1">
              <a:avLst/>
            </a:prstGeom>
            <a:ln w="28575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8BBE2180-A1FD-4E9E-94A7-7D1960E06255}"/>
                </a:ext>
              </a:extLst>
            </p:cNvPr>
            <p:cNvSpPr txBox="1"/>
            <p:nvPr/>
          </p:nvSpPr>
          <p:spPr>
            <a:xfrm>
              <a:off x="5237329" y="1111686"/>
              <a:ext cx="29479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Sacrifice : Lung and spleen collection 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357B454-7FAE-41DB-AC38-9FE8D05EEB9B}"/>
                </a:ext>
              </a:extLst>
            </p:cNvPr>
            <p:cNvSpPr txBox="1"/>
            <p:nvPr/>
          </p:nvSpPr>
          <p:spPr>
            <a:xfrm>
              <a:off x="-1361363" y="1049511"/>
              <a:ext cx="20826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err="1">
                  <a:solidFill>
                    <a:srgbClr val="7030A0"/>
                  </a:solidFill>
                </a:rPr>
                <a:t>Fc</a:t>
              </a:r>
              <a:r>
                <a:rPr lang="fr-FR" b="1" dirty="0">
                  <a:solidFill>
                    <a:srgbClr val="7030A0"/>
                  </a:solidFill>
                </a:rPr>
                <a:t> Control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FC4F550A-4D37-4CB9-B6D3-99881BCE65E6}"/>
                </a:ext>
              </a:extLst>
            </p:cNvPr>
            <p:cNvSpPr txBox="1"/>
            <p:nvPr/>
          </p:nvSpPr>
          <p:spPr>
            <a:xfrm>
              <a:off x="1951631" y="1299742"/>
              <a:ext cx="3166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/>
                <a:t>i.p</a:t>
              </a:r>
              <a:r>
                <a:rPr lang="fr-FR" sz="1200" dirty="0"/>
                <a:t>. </a:t>
              </a:r>
              <a:r>
                <a:rPr lang="fr-FR" sz="1200" dirty="0" err="1"/>
                <a:t>Fc</a:t>
              </a:r>
              <a:r>
                <a:rPr lang="fr-FR" sz="1200" dirty="0"/>
                <a:t> Control injection : 2 </a:t>
              </a:r>
              <a:r>
                <a:rPr lang="fr-FR" sz="1200" dirty="0" err="1"/>
                <a:t>days</a:t>
              </a:r>
              <a:r>
                <a:rPr lang="fr-FR" sz="1200" dirty="0"/>
                <a:t>/</a:t>
              </a:r>
              <a:r>
                <a:rPr lang="fr-FR" sz="1200" dirty="0" err="1"/>
                <a:t>week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71F60424-ABBF-4A67-AFE7-CC77845928D0}"/>
                </a:ext>
              </a:extLst>
            </p:cNvPr>
            <p:cNvSpPr txBox="1"/>
            <p:nvPr/>
          </p:nvSpPr>
          <p:spPr>
            <a:xfrm>
              <a:off x="1252183" y="795270"/>
              <a:ext cx="9758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Day 1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0034D269-9FB5-46E7-A4EA-0AC1BA51BF6B}"/>
                </a:ext>
              </a:extLst>
            </p:cNvPr>
            <p:cNvSpPr txBox="1"/>
            <p:nvPr/>
          </p:nvSpPr>
          <p:spPr>
            <a:xfrm>
              <a:off x="4841544" y="800385"/>
              <a:ext cx="9758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Day 42</a:t>
              </a:r>
            </a:p>
          </p:txBody>
        </p:sp>
        <p:cxnSp>
          <p:nvCxnSpPr>
            <p:cNvPr id="39" name="Connecteur droit 38">
              <a:extLst>
                <a:ext uri="{FF2B5EF4-FFF2-40B4-BE49-F238E27FC236}">
                  <a16:creationId xmlns:a16="http://schemas.microsoft.com/office/drawing/2014/main" id="{E3F1B38E-867B-4D01-8114-B396D8AF4CE1}"/>
                </a:ext>
              </a:extLst>
            </p:cNvPr>
            <p:cNvCxnSpPr/>
            <p:nvPr/>
          </p:nvCxnSpPr>
          <p:spPr>
            <a:xfrm>
              <a:off x="1740090" y="1049511"/>
              <a:ext cx="0" cy="224105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>
              <a:extLst>
                <a:ext uri="{FF2B5EF4-FFF2-40B4-BE49-F238E27FC236}">
                  <a16:creationId xmlns:a16="http://schemas.microsoft.com/office/drawing/2014/main" id="{D53202A0-47A1-4288-AA5B-094A40E28746}"/>
                </a:ext>
              </a:extLst>
            </p:cNvPr>
            <p:cNvCxnSpPr/>
            <p:nvPr/>
          </p:nvCxnSpPr>
          <p:spPr>
            <a:xfrm>
              <a:off x="5329452" y="1052711"/>
              <a:ext cx="0" cy="224105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DAD1F173-D23E-4505-84EA-8F5359C18D72}"/>
                </a:ext>
              </a:extLst>
            </p:cNvPr>
            <p:cNvSpPr txBox="1"/>
            <p:nvPr/>
          </p:nvSpPr>
          <p:spPr>
            <a:xfrm>
              <a:off x="251476" y="379414"/>
              <a:ext cx="180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Fra-2 </a:t>
              </a:r>
              <a:r>
                <a:rPr lang="fr-FR" sz="1200" b="1" dirty="0" err="1"/>
                <a:t>mice</a:t>
              </a:r>
              <a:endParaRPr lang="fr-FR" sz="1200" b="1" dirty="0"/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9D091B30-8ECA-44A5-8D90-AD927C2BA205}"/>
                </a:ext>
              </a:extLst>
            </p:cNvPr>
            <p:cNvSpPr txBox="1"/>
            <p:nvPr/>
          </p:nvSpPr>
          <p:spPr>
            <a:xfrm>
              <a:off x="251476" y="580329"/>
              <a:ext cx="180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i="1" dirty="0"/>
                <a:t>12 </a:t>
              </a:r>
              <a:r>
                <a:rPr lang="fr-FR" sz="1200" b="1" i="1" dirty="0" err="1"/>
                <a:t>weeks</a:t>
              </a:r>
              <a:r>
                <a:rPr lang="fr-FR" sz="1200" b="1" i="1" dirty="0"/>
                <a:t> </a:t>
              </a:r>
              <a:r>
                <a:rPr lang="fr-FR" sz="1200" b="1" i="1" dirty="0" err="1"/>
                <a:t>old</a:t>
              </a:r>
              <a:endParaRPr lang="fr-FR" sz="1200" b="1" i="1" dirty="0"/>
            </a:p>
          </p:txBody>
        </p:sp>
      </p:grpSp>
      <p:sp>
        <p:nvSpPr>
          <p:cNvPr id="35" name="ZoneTexte 34">
            <a:extLst>
              <a:ext uri="{FF2B5EF4-FFF2-40B4-BE49-F238E27FC236}">
                <a16:creationId xmlns:a16="http://schemas.microsoft.com/office/drawing/2014/main" id="{A380A0C1-AD5F-4AFB-8701-47EE7426FD1C}"/>
              </a:ext>
            </a:extLst>
          </p:cNvPr>
          <p:cNvSpPr txBox="1"/>
          <p:nvPr/>
        </p:nvSpPr>
        <p:spPr>
          <a:xfrm>
            <a:off x="274320" y="192446"/>
            <a:ext cx="248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</a:t>
            </a:r>
            <a:r>
              <a:rPr lang="fr-FR"/>
              <a:t>Figure 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244368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Grand écran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indy</dc:creator>
  <cp:lastModifiedBy>Cindy Orvain</cp:lastModifiedBy>
  <cp:revision>2</cp:revision>
  <dcterms:created xsi:type="dcterms:W3CDTF">2021-09-15T12:34:51Z</dcterms:created>
  <dcterms:modified xsi:type="dcterms:W3CDTF">2021-12-12T10:00:50Z</dcterms:modified>
</cp:coreProperties>
</file>